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9D862A-1411-494B-B2D7-D5F7078A574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A25913-08BC-446E-BCAA-6C9A226A626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3B2315-4250-40E8-B179-146032C27CC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146158-049C-4F61-B3AB-0AE071C2318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062055-5142-4D50-BE50-16A3E5C470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F6737A-734D-42C6-A43F-41B0BDD5A5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42D27F-3EEF-4309-87F4-4694EF975F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686757-7947-421B-B62F-48E6F5744F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B510E1-CA7B-40CB-879E-E003F8C185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BF52AE-830D-4DCE-8384-82933A51C2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EFD900-B96F-4290-967F-746131AF5C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249F82-E982-4E51-A00E-EE7FAF2C2C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06079D-5076-440F-8C42-84023D00D41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533520" y="1828800"/>
          <a:ext cx="8229600" cy="1871640"/>
        </p:xfrm>
        <a:graphic>
          <a:graphicData uri="http://schemas.openxmlformats.org/drawingml/2006/table">
            <a:tbl>
              <a:tblPr/>
              <a:tblGrid>
                <a:gridCol w="1890720"/>
                <a:gridCol w="3327120"/>
                <a:gridCol w="3011760"/>
              </a:tblGrid>
              <a:tr h="2588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orward 5'→3'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verse 5'→3'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660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gal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agtccgcatcttccatca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ggtgctgccagttac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456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ubil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cacggcactcacagcaa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tagggcatcggggtagttg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xni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tgtacgcccctgagttc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gctcactgcacgttgttgt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-a Hydroxyla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ggcggatggtgaagaa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tgtccagagttccagcata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264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lbindin D-9k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aatatgcagccaaggaag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cgccattcttatccagct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lbindin D-28k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aatggccttgtcggat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tagcaagtggttgtggtca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3259440" y="1104840"/>
            <a:ext cx="232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upplementary Tabl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535680" y="3733920"/>
            <a:ext cx="183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rimers used for qRT-PC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"/>
          <p:cNvSpPr/>
          <p:nvPr/>
        </p:nvSpPr>
        <p:spPr>
          <a:xfrm>
            <a:off x="3259440" y="1104840"/>
            <a:ext cx="232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Supplementary Tabl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5" name=""/>
          <p:cNvGraphicFramePr/>
          <p:nvPr/>
        </p:nvGraphicFramePr>
        <p:xfrm>
          <a:off x="457200" y="1600200"/>
          <a:ext cx="8229600" cy="2516040"/>
        </p:xfrm>
        <a:graphic>
          <a:graphicData uri="http://schemas.openxmlformats.org/drawingml/2006/table">
            <a:tbl>
              <a:tblPr/>
              <a:tblGrid>
                <a:gridCol w="2228760"/>
                <a:gridCol w="2057400"/>
                <a:gridCol w="1886040"/>
                <a:gridCol w="2057400"/>
              </a:tblGrid>
              <a:tr h="457200"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ontro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iabet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-valu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87240"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Urine VDBP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.4 ±  2.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.15 ± 0.3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85800"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lb/CR wk 10 (µg/ml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2.8 ± 38.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3.6 ± 26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85800"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lucose wk 10 (mg/dl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38.2 ± 46.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22.4 ± 131.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&lt; 0.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6" name=""/>
          <p:cNvSpPr/>
          <p:nvPr/>
        </p:nvSpPr>
        <p:spPr>
          <a:xfrm>
            <a:off x="593640" y="4419720"/>
            <a:ext cx="8321760" cy="91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able 1: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haracteristics of C57B/6 mice without (control) and with (diabetes) STZ-induced diabetes (diabetes). Urine VDBP, Alb/Cr and glucose were measured after 10 week of diabetes as described in Materials and Methods. Data expressed as mean ± SD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Supplementary Figure S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8" name=""/>
          <p:cNvGrpSpPr/>
          <p:nvPr/>
        </p:nvGrpSpPr>
        <p:grpSpPr>
          <a:xfrm>
            <a:off x="2543040" y="1874880"/>
            <a:ext cx="3462480" cy="3267000"/>
            <a:chOff x="2543040" y="1874880"/>
            <a:chExt cx="3462480" cy="3267000"/>
          </a:xfrm>
        </p:grpSpPr>
        <p:sp>
          <p:nvSpPr>
            <p:cNvPr id="49" name=""/>
            <p:cNvSpPr/>
            <p:nvPr/>
          </p:nvSpPr>
          <p:spPr>
            <a:xfrm>
              <a:off x="2543040" y="1874880"/>
              <a:ext cx="18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260880" y="2130480"/>
              <a:ext cx="2743200" cy="183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3260880" y="3959280"/>
              <a:ext cx="18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27960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329724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31632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33540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335268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37176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38940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40848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342576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344484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346248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348156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349884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51792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353520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355428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357192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359100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60828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62736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64500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66408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368136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70044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371952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73680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375588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377352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379260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380988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382896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84660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86568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388296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390204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391968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393876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395604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397512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399240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401148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402912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404820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406548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408456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410364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412128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414036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415764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417672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419400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421308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423072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424980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426708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428616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430380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432288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434016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435924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437688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439596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441324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443232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444960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446868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448776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450540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452448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454176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456084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457848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459756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461484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463392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465120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467028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468792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470700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472428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474336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476100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478008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479736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481644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483408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4853160" y="3959280"/>
              <a:ext cx="18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487188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488952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490860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492588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494496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496260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498168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499896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501804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503568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505476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507204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509112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510840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512748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514512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516420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518148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520056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521820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523728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525636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527364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529272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5310360" y="3959280"/>
              <a:ext cx="18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532908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534672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536580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538308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540216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541980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543888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545616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547524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549288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551196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552924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554832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556560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558468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560232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562140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563868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565776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567684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569448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571356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573084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574992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5767560" y="3959280"/>
              <a:ext cx="18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578628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580392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582300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584028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585936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587700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589608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591336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5932440" y="3959280"/>
              <a:ext cx="17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595008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5969160" y="3959280"/>
              <a:ext cx="17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5986440" y="3959280"/>
              <a:ext cx="19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3489480" y="3959280"/>
              <a:ext cx="0" cy="507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 rot="18900000">
              <a:off x="2657520" y="4858920"/>
              <a:ext cx="144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3948120" y="3959280"/>
              <a:ext cx="0" cy="507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 rot="18900000">
              <a:off x="3066840" y="4906800"/>
              <a:ext cx="144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4405320" y="3959280"/>
              <a:ext cx="0" cy="507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 rot="18900000">
              <a:off x="3571920" y="4858920"/>
              <a:ext cx="144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4862520" y="3959280"/>
              <a:ext cx="0" cy="507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 rot="18900000">
              <a:off x="3982680" y="4906800"/>
              <a:ext cx="144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5319720" y="3959280"/>
              <a:ext cx="0" cy="507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 rot="18900000">
              <a:off x="4487760" y="4858920"/>
              <a:ext cx="18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5776920" y="3959280"/>
              <a:ext cx="0" cy="507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 rot="18900000">
              <a:off x="5087880" y="4717800"/>
              <a:ext cx="18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 flipV="1">
              <a:off x="3260880" y="3939840"/>
              <a:ext cx="0" cy="19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 flipV="1">
              <a:off x="3260880" y="3922200"/>
              <a:ext cx="0" cy="17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 flipV="1">
              <a:off x="3260880" y="3903840"/>
              <a:ext cx="0" cy="18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 flipV="1">
              <a:off x="3260880" y="3885840"/>
              <a:ext cx="0" cy="17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 flipV="1">
              <a:off x="3260880" y="3866760"/>
              <a:ext cx="0" cy="19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 flipV="1">
              <a:off x="3260880" y="3849840"/>
              <a:ext cx="0" cy="17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 flipV="1">
              <a:off x="3260880" y="3830400"/>
              <a:ext cx="0" cy="19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 flipV="1">
              <a:off x="3260880" y="3812760"/>
              <a:ext cx="0" cy="17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 flipV="1">
              <a:off x="3260880" y="3793680"/>
              <a:ext cx="0" cy="19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 flipV="1">
              <a:off x="3260880" y="3776760"/>
              <a:ext cx="0" cy="17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 flipV="1">
              <a:off x="3260880" y="3757320"/>
              <a:ext cx="0" cy="19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 flipV="1">
              <a:off x="3260880" y="3738240"/>
              <a:ext cx="0" cy="19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 flipV="1">
              <a:off x="3260880" y="3720600"/>
              <a:ext cx="0" cy="17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 flipV="1">
              <a:off x="3260880" y="3702240"/>
              <a:ext cx="0" cy="18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 flipV="1">
              <a:off x="3260880" y="3684240"/>
              <a:ext cx="0" cy="17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 flipV="1">
              <a:off x="3260880" y="3665160"/>
              <a:ext cx="0" cy="19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 flipV="1">
              <a:off x="3260880" y="3648240"/>
              <a:ext cx="0" cy="17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 flipV="1">
              <a:off x="3260880" y="3628800"/>
              <a:ext cx="0" cy="19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 flipV="1">
              <a:off x="3260880" y="3611160"/>
              <a:ext cx="0" cy="17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 flipV="1">
              <a:off x="3260880" y="3592080"/>
              <a:ext cx="0" cy="19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 flipV="1">
              <a:off x="3260880" y="3575160"/>
              <a:ext cx="0" cy="17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 flipV="1">
              <a:off x="3260880" y="3555720"/>
              <a:ext cx="0" cy="19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 flipV="1">
              <a:off x="3260880" y="3538080"/>
              <a:ext cx="0" cy="17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 flipV="1">
              <a:off x="3260880" y="3519000"/>
              <a:ext cx="0" cy="19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 flipV="1">
              <a:off x="3260880" y="3502080"/>
              <a:ext cx="0" cy="17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 flipV="1">
              <a:off x="3260880" y="3482640"/>
              <a:ext cx="0" cy="19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 flipV="1">
              <a:off x="3260880" y="3465000"/>
              <a:ext cx="0" cy="17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 flipV="1">
              <a:off x="3260880" y="3446640"/>
              <a:ext cx="0" cy="18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 flipV="1">
              <a:off x="3260880" y="3428640"/>
              <a:ext cx="0" cy="17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 flipV="1">
              <a:off x="3260880" y="3409560"/>
              <a:ext cx="0" cy="19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 flipV="1">
              <a:off x="3260880" y="3392640"/>
              <a:ext cx="0" cy="17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 flipV="1">
              <a:off x="3260880" y="3373200"/>
              <a:ext cx="0" cy="19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 flipV="1">
              <a:off x="3260880" y="3355560"/>
              <a:ext cx="0" cy="17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 flipV="1">
              <a:off x="3260880" y="3336480"/>
              <a:ext cx="0" cy="19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 flipV="1">
              <a:off x="3260880" y="3319560"/>
              <a:ext cx="0" cy="17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 flipV="1">
              <a:off x="3260880" y="3300120"/>
              <a:ext cx="0" cy="19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9" name=""/>
          <p:cNvSpPr/>
          <p:nvPr/>
        </p:nvSpPr>
        <p:spPr>
          <a:xfrm flipV="1">
            <a:off x="3260880" y="329040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 flipV="1">
            <a:off x="3260880" y="327132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 flipV="1">
            <a:off x="3260880" y="3252960"/>
            <a:ext cx="0" cy="187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 flipV="1">
            <a:off x="3260880" y="323496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 flipV="1">
            <a:off x="3260880" y="321588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 flipV="1">
            <a:off x="3260880" y="319896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 flipV="1">
            <a:off x="3260880" y="317952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 flipV="1">
            <a:off x="3260880" y="316188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 flipV="1">
            <a:off x="3260880" y="314280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 flipV="1">
            <a:off x="3260880" y="312588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 flipV="1">
            <a:off x="3260880" y="310644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 flipV="1">
            <a:off x="3260880" y="308880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 flipV="1">
            <a:off x="3260880" y="306972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 flipV="1">
            <a:off x="3260880" y="305280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 flipV="1">
            <a:off x="3260880" y="303336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 flipV="1">
            <a:off x="3260880" y="301572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 flipV="1">
            <a:off x="3260880" y="2997360"/>
            <a:ext cx="0" cy="187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 flipV="1">
            <a:off x="3260880" y="297936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 flipV="1">
            <a:off x="3260880" y="296028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 flipV="1">
            <a:off x="3260880" y="294336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 flipV="1">
            <a:off x="3260880" y="292392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 flipV="1">
            <a:off x="3260880" y="290628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 flipV="1">
            <a:off x="3260880" y="288720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 flipV="1">
            <a:off x="3260880" y="287028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 flipV="1">
            <a:off x="3260880" y="285084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 flipV="1">
            <a:off x="3260880" y="283320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 flipV="1">
            <a:off x="3260880" y="281412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 flipV="1">
            <a:off x="3260880" y="279720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 flipV="1">
            <a:off x="3260880" y="277776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 flipV="1">
            <a:off x="3260880" y="275868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 flipV="1">
            <a:off x="3260880" y="274176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 flipV="1">
            <a:off x="3260880" y="272232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 flipV="1">
            <a:off x="3260880" y="270468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 flipV="1">
            <a:off x="3260880" y="268560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 flipV="1">
            <a:off x="3260880" y="266868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 flipV="1">
            <a:off x="3260880" y="264924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 flipV="1">
            <a:off x="3260880" y="263160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 flipV="1">
            <a:off x="3260880" y="261252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 flipV="1">
            <a:off x="3260880" y="259560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 flipV="1">
            <a:off x="3260880" y="257616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 flipV="1">
            <a:off x="3260880" y="255852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 flipV="1">
            <a:off x="3260880" y="2540160"/>
            <a:ext cx="0" cy="187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8080" bIns="-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 flipV="1">
            <a:off x="3260880" y="252216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 flipV="1">
            <a:off x="3260880" y="250308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 flipV="1">
            <a:off x="3260880" y="248616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 flipV="1">
            <a:off x="3260880" y="246672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 flipV="1">
            <a:off x="3260880" y="244908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 flipV="1">
            <a:off x="3260880" y="243000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 flipV="1">
            <a:off x="3260880" y="241308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 flipV="1">
            <a:off x="3260880" y="239364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 flipV="1">
            <a:off x="3260880" y="237600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 flipV="1">
            <a:off x="3260880" y="235692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 flipV="1">
            <a:off x="3260880" y="234000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 flipV="1">
            <a:off x="3260880" y="232056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 flipV="1">
            <a:off x="3260880" y="230148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 flipV="1">
            <a:off x="3260880" y="228456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 flipV="1">
            <a:off x="3260880" y="226512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 flipV="1">
            <a:off x="3260880" y="224748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 flipV="1">
            <a:off x="3260880" y="222840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 flipV="1">
            <a:off x="3260880" y="221148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 flipV="1">
            <a:off x="3260880" y="219204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 flipV="1">
            <a:off x="3260880" y="2174400"/>
            <a:ext cx="0" cy="17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 flipV="1">
            <a:off x="3260880" y="2155320"/>
            <a:ext cx="0" cy="19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 flipV="1">
            <a:off x="3260880" y="2138400"/>
            <a:ext cx="0" cy="1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 flipH="1">
            <a:off x="3209760" y="3967200"/>
            <a:ext cx="51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3045960" y="3884760"/>
            <a:ext cx="78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 flipH="1">
            <a:off x="3209760" y="3600360"/>
            <a:ext cx="51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2890440" y="3519360"/>
            <a:ext cx="234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 flipH="1">
            <a:off x="3209760" y="3235320"/>
            <a:ext cx="51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>
            <a:off x="2890440" y="3152880"/>
            <a:ext cx="234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 flipH="1">
            <a:off x="3209760" y="2870280"/>
            <a:ext cx="51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>
            <a:off x="2890440" y="2787480"/>
            <a:ext cx="234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 flipH="1">
            <a:off x="3209760" y="2503440"/>
            <a:ext cx="51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>
            <a:off x="2890440" y="2421000"/>
            <a:ext cx="234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4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 flipH="1">
            <a:off x="3209760" y="2138400"/>
            <a:ext cx="51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2890440" y="2055960"/>
            <a:ext cx="234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3867120" y="3141720"/>
            <a:ext cx="73080" cy="73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3813120" y="3424320"/>
            <a:ext cx="73080" cy="73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>
            <a:off x="3813120" y="2917800"/>
            <a:ext cx="73080" cy="73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>
            <a:off x="3757680" y="3600360"/>
            <a:ext cx="73080" cy="73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>
            <a:off x="3757680" y="3679920"/>
            <a:ext cx="73080" cy="73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>
            <a:off x="3867120" y="3732120"/>
            <a:ext cx="73080" cy="73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3757680" y="3246480"/>
            <a:ext cx="73080" cy="73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3813120" y="3919680"/>
            <a:ext cx="73080" cy="7272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3813120" y="2712960"/>
            <a:ext cx="73080" cy="73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3867120" y="3527280"/>
            <a:ext cx="73080" cy="73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>
            <a:off x="3849840" y="3305160"/>
            <a:ext cx="0" cy="24300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>
            <a:off x="3773520" y="3305160"/>
            <a:ext cx="15228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 flipH="1">
            <a:off x="3773160" y="3305160"/>
            <a:ext cx="15228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3773520" y="3548160"/>
            <a:ext cx="15228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 flipH="1">
            <a:off x="3773160" y="3548160"/>
            <a:ext cx="15228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3795840" y="342756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3813120" y="342756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3733920" y="342756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3751200" y="342756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3770280" y="342756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>
            <a:off x="3787920" y="342756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>
            <a:off x="3807000" y="342756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3824280" y="342756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>
            <a:off x="3843360" y="342756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>
            <a:off x="3860640" y="342756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>
            <a:off x="3879720" y="342756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"/>
          <p:cNvSpPr/>
          <p:nvPr/>
        </p:nvSpPr>
        <p:spPr>
          <a:xfrm>
            <a:off x="3897360" y="342756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"/>
          <p:cNvSpPr/>
          <p:nvPr/>
        </p:nvSpPr>
        <p:spPr>
          <a:xfrm>
            <a:off x="3916440" y="342756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"/>
          <p:cNvSpPr/>
          <p:nvPr/>
        </p:nvSpPr>
        <p:spPr>
          <a:xfrm>
            <a:off x="3894120" y="342756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"/>
          <p:cNvSpPr/>
          <p:nvPr/>
        </p:nvSpPr>
        <p:spPr>
          <a:xfrm>
            <a:off x="3913200" y="342756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"/>
          <p:cNvSpPr/>
          <p:nvPr/>
        </p:nvSpPr>
        <p:spPr>
          <a:xfrm>
            <a:off x="3930480" y="342756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"/>
          <p:cNvSpPr/>
          <p:nvPr/>
        </p:nvSpPr>
        <p:spPr>
          <a:xfrm>
            <a:off x="3949560" y="3427560"/>
            <a:ext cx="129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"/>
          <p:cNvSpPr/>
          <p:nvPr/>
        </p:nvSpPr>
        <p:spPr>
          <a:xfrm>
            <a:off x="4818240" y="3919680"/>
            <a:ext cx="72720" cy="7272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"/>
          <p:cNvSpPr/>
          <p:nvPr/>
        </p:nvSpPr>
        <p:spPr>
          <a:xfrm>
            <a:off x="4873680" y="3495600"/>
            <a:ext cx="73080" cy="73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"/>
          <p:cNvSpPr/>
          <p:nvPr/>
        </p:nvSpPr>
        <p:spPr>
          <a:xfrm>
            <a:off x="4873680" y="3919680"/>
            <a:ext cx="73080" cy="7272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"/>
          <p:cNvSpPr/>
          <p:nvPr/>
        </p:nvSpPr>
        <p:spPr>
          <a:xfrm>
            <a:off x="4654440" y="3919680"/>
            <a:ext cx="73080" cy="7272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"/>
          <p:cNvSpPr/>
          <p:nvPr/>
        </p:nvSpPr>
        <p:spPr>
          <a:xfrm>
            <a:off x="4764240" y="3919680"/>
            <a:ext cx="72720" cy="7272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"/>
          <p:cNvSpPr/>
          <p:nvPr/>
        </p:nvSpPr>
        <p:spPr>
          <a:xfrm>
            <a:off x="4764240" y="3594240"/>
            <a:ext cx="72720" cy="7272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"/>
          <p:cNvSpPr/>
          <p:nvPr/>
        </p:nvSpPr>
        <p:spPr>
          <a:xfrm>
            <a:off x="4708440" y="3919680"/>
            <a:ext cx="73080" cy="7272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"/>
          <p:cNvSpPr/>
          <p:nvPr/>
        </p:nvSpPr>
        <p:spPr>
          <a:xfrm>
            <a:off x="4654440" y="3548160"/>
            <a:ext cx="73080" cy="73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"/>
          <p:cNvSpPr/>
          <p:nvPr/>
        </p:nvSpPr>
        <p:spPr>
          <a:xfrm>
            <a:off x="4764240" y="3457440"/>
            <a:ext cx="72720" cy="73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"/>
          <p:cNvSpPr/>
          <p:nvPr/>
        </p:nvSpPr>
        <p:spPr>
          <a:xfrm>
            <a:off x="4800600" y="3708360"/>
            <a:ext cx="0" cy="14292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"/>
          <p:cNvSpPr/>
          <p:nvPr/>
        </p:nvSpPr>
        <p:spPr>
          <a:xfrm>
            <a:off x="4724280" y="3708360"/>
            <a:ext cx="15264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"/>
          <p:cNvSpPr/>
          <p:nvPr/>
        </p:nvSpPr>
        <p:spPr>
          <a:xfrm flipH="1">
            <a:off x="4724280" y="3708360"/>
            <a:ext cx="15264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"/>
          <p:cNvSpPr/>
          <p:nvPr/>
        </p:nvSpPr>
        <p:spPr>
          <a:xfrm>
            <a:off x="4724280" y="3851280"/>
            <a:ext cx="15264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"/>
          <p:cNvSpPr/>
          <p:nvPr/>
        </p:nvSpPr>
        <p:spPr>
          <a:xfrm flipH="1">
            <a:off x="4724280" y="3851280"/>
            <a:ext cx="15264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"/>
          <p:cNvSpPr/>
          <p:nvPr/>
        </p:nvSpPr>
        <p:spPr>
          <a:xfrm>
            <a:off x="4648320" y="378144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"/>
          <p:cNvSpPr/>
          <p:nvPr/>
        </p:nvSpPr>
        <p:spPr>
          <a:xfrm>
            <a:off x="4665600" y="37814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"/>
          <p:cNvSpPr/>
          <p:nvPr/>
        </p:nvSpPr>
        <p:spPr>
          <a:xfrm>
            <a:off x="4684680" y="378144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"/>
          <p:cNvSpPr/>
          <p:nvPr/>
        </p:nvSpPr>
        <p:spPr>
          <a:xfrm>
            <a:off x="4702320" y="37814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"/>
          <p:cNvSpPr/>
          <p:nvPr/>
        </p:nvSpPr>
        <p:spPr>
          <a:xfrm>
            <a:off x="4721400" y="378144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"/>
          <p:cNvSpPr/>
          <p:nvPr/>
        </p:nvSpPr>
        <p:spPr>
          <a:xfrm>
            <a:off x="4738680" y="37814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"/>
          <p:cNvSpPr/>
          <p:nvPr/>
        </p:nvSpPr>
        <p:spPr>
          <a:xfrm>
            <a:off x="4757760" y="378144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"/>
          <p:cNvSpPr/>
          <p:nvPr/>
        </p:nvSpPr>
        <p:spPr>
          <a:xfrm>
            <a:off x="4775040" y="37814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"/>
          <p:cNvSpPr/>
          <p:nvPr/>
        </p:nvSpPr>
        <p:spPr>
          <a:xfrm>
            <a:off x="4794120" y="378144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"/>
          <p:cNvSpPr/>
          <p:nvPr/>
        </p:nvSpPr>
        <p:spPr>
          <a:xfrm>
            <a:off x="4811760" y="37814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"/>
          <p:cNvSpPr/>
          <p:nvPr/>
        </p:nvSpPr>
        <p:spPr>
          <a:xfrm>
            <a:off x="4830840" y="378144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"/>
          <p:cNvSpPr/>
          <p:nvPr/>
        </p:nvSpPr>
        <p:spPr>
          <a:xfrm>
            <a:off x="4848120" y="37814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"/>
          <p:cNvSpPr/>
          <p:nvPr/>
        </p:nvSpPr>
        <p:spPr>
          <a:xfrm>
            <a:off x="4867200" y="37814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"/>
          <p:cNvSpPr/>
          <p:nvPr/>
        </p:nvSpPr>
        <p:spPr>
          <a:xfrm>
            <a:off x="4886280" y="378144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"/>
          <p:cNvSpPr/>
          <p:nvPr/>
        </p:nvSpPr>
        <p:spPr>
          <a:xfrm>
            <a:off x="4903920" y="37814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"/>
          <p:cNvSpPr/>
          <p:nvPr/>
        </p:nvSpPr>
        <p:spPr>
          <a:xfrm>
            <a:off x="4923000" y="378144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"/>
          <p:cNvSpPr/>
          <p:nvPr/>
        </p:nvSpPr>
        <p:spPr>
          <a:xfrm>
            <a:off x="4940280" y="3781440"/>
            <a:ext cx="126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"/>
          <p:cNvSpPr/>
          <p:nvPr/>
        </p:nvSpPr>
        <p:spPr>
          <a:xfrm>
            <a:off x="5559480" y="2401920"/>
            <a:ext cx="73080" cy="73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"/>
          <p:cNvSpPr/>
          <p:nvPr/>
        </p:nvSpPr>
        <p:spPr>
          <a:xfrm>
            <a:off x="5668920" y="2496960"/>
            <a:ext cx="74520" cy="73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"/>
          <p:cNvSpPr/>
          <p:nvPr/>
        </p:nvSpPr>
        <p:spPr>
          <a:xfrm>
            <a:off x="5559480" y="3738600"/>
            <a:ext cx="73080" cy="73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"/>
          <p:cNvSpPr/>
          <p:nvPr/>
        </p:nvSpPr>
        <p:spPr>
          <a:xfrm>
            <a:off x="5668920" y="3798720"/>
            <a:ext cx="74520" cy="7308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"/>
          <p:cNvSpPr/>
          <p:nvPr/>
        </p:nvSpPr>
        <p:spPr>
          <a:xfrm>
            <a:off x="5614920" y="3919680"/>
            <a:ext cx="73080" cy="7272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"/>
          <p:cNvSpPr/>
          <p:nvPr/>
        </p:nvSpPr>
        <p:spPr>
          <a:xfrm>
            <a:off x="5614920" y="3367080"/>
            <a:ext cx="73080" cy="74520"/>
          </a:xfrm>
          <a:prstGeom prst="ellipse">
            <a:avLst/>
          </a:prstGeom>
          <a:solidFill>
            <a:srgbClr val="000000"/>
          </a:solidFill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6120" bIns="6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"/>
          <p:cNvSpPr/>
          <p:nvPr/>
        </p:nvSpPr>
        <p:spPr>
          <a:xfrm>
            <a:off x="5651640" y="3048120"/>
            <a:ext cx="0" cy="55080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"/>
          <p:cNvSpPr/>
          <p:nvPr/>
        </p:nvSpPr>
        <p:spPr>
          <a:xfrm>
            <a:off x="5575320" y="3048120"/>
            <a:ext cx="15228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"/>
          <p:cNvSpPr/>
          <p:nvPr/>
        </p:nvSpPr>
        <p:spPr>
          <a:xfrm flipH="1">
            <a:off x="5574960" y="3048120"/>
            <a:ext cx="15228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"/>
          <p:cNvSpPr/>
          <p:nvPr/>
        </p:nvSpPr>
        <p:spPr>
          <a:xfrm>
            <a:off x="5575320" y="3598920"/>
            <a:ext cx="15228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"/>
          <p:cNvSpPr/>
          <p:nvPr/>
        </p:nvSpPr>
        <p:spPr>
          <a:xfrm flipH="1">
            <a:off x="5574960" y="3598920"/>
            <a:ext cx="15228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"/>
          <p:cNvSpPr/>
          <p:nvPr/>
        </p:nvSpPr>
        <p:spPr>
          <a:xfrm>
            <a:off x="5499000" y="332424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"/>
          <p:cNvSpPr/>
          <p:nvPr/>
        </p:nvSpPr>
        <p:spPr>
          <a:xfrm>
            <a:off x="5516640" y="33242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"/>
          <p:cNvSpPr/>
          <p:nvPr/>
        </p:nvSpPr>
        <p:spPr>
          <a:xfrm>
            <a:off x="5535720" y="332424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"/>
          <p:cNvSpPr/>
          <p:nvPr/>
        </p:nvSpPr>
        <p:spPr>
          <a:xfrm>
            <a:off x="5553000" y="33242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"/>
          <p:cNvSpPr/>
          <p:nvPr/>
        </p:nvSpPr>
        <p:spPr>
          <a:xfrm>
            <a:off x="5572080" y="33242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"/>
          <p:cNvSpPr/>
          <p:nvPr/>
        </p:nvSpPr>
        <p:spPr>
          <a:xfrm>
            <a:off x="5591160" y="332424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"/>
          <p:cNvSpPr/>
          <p:nvPr/>
        </p:nvSpPr>
        <p:spPr>
          <a:xfrm>
            <a:off x="5608800" y="3324240"/>
            <a:ext cx="18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"/>
          <p:cNvSpPr/>
          <p:nvPr/>
        </p:nvSpPr>
        <p:spPr>
          <a:xfrm>
            <a:off x="5627520" y="332424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"/>
          <p:cNvSpPr/>
          <p:nvPr/>
        </p:nvSpPr>
        <p:spPr>
          <a:xfrm>
            <a:off x="5645160" y="33242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"/>
          <p:cNvSpPr/>
          <p:nvPr/>
        </p:nvSpPr>
        <p:spPr>
          <a:xfrm>
            <a:off x="5664240" y="332424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"/>
          <p:cNvSpPr/>
          <p:nvPr/>
        </p:nvSpPr>
        <p:spPr>
          <a:xfrm>
            <a:off x="5681520" y="33242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"/>
          <p:cNvSpPr/>
          <p:nvPr/>
        </p:nvSpPr>
        <p:spPr>
          <a:xfrm>
            <a:off x="5700600" y="332424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"/>
          <p:cNvSpPr/>
          <p:nvPr/>
        </p:nvSpPr>
        <p:spPr>
          <a:xfrm>
            <a:off x="5718240" y="33242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"/>
          <p:cNvSpPr/>
          <p:nvPr/>
        </p:nvSpPr>
        <p:spPr>
          <a:xfrm>
            <a:off x="5737320" y="332424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"/>
          <p:cNvSpPr/>
          <p:nvPr/>
        </p:nvSpPr>
        <p:spPr>
          <a:xfrm>
            <a:off x="5754600" y="33242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"/>
          <p:cNvSpPr/>
          <p:nvPr/>
        </p:nvSpPr>
        <p:spPr>
          <a:xfrm>
            <a:off x="5773680" y="332424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"/>
          <p:cNvSpPr/>
          <p:nvPr/>
        </p:nvSpPr>
        <p:spPr>
          <a:xfrm>
            <a:off x="5778360" y="3324240"/>
            <a:ext cx="129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"/>
          <p:cNvSpPr/>
          <p:nvPr/>
        </p:nvSpPr>
        <p:spPr>
          <a:xfrm>
            <a:off x="3508200" y="3325680"/>
            <a:ext cx="73080" cy="7308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"/>
          <p:cNvSpPr/>
          <p:nvPr/>
        </p:nvSpPr>
        <p:spPr>
          <a:xfrm>
            <a:off x="3398760" y="3919680"/>
            <a:ext cx="73080" cy="7272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"/>
          <p:cNvSpPr/>
          <p:nvPr/>
        </p:nvSpPr>
        <p:spPr>
          <a:xfrm>
            <a:off x="3508200" y="3695760"/>
            <a:ext cx="73080" cy="7308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"/>
          <p:cNvSpPr/>
          <p:nvPr/>
        </p:nvSpPr>
        <p:spPr>
          <a:xfrm>
            <a:off x="3343320" y="3632040"/>
            <a:ext cx="73080" cy="7308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"/>
          <p:cNvSpPr/>
          <p:nvPr/>
        </p:nvSpPr>
        <p:spPr>
          <a:xfrm>
            <a:off x="3452760" y="3635280"/>
            <a:ext cx="74520" cy="7308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"/>
          <p:cNvSpPr/>
          <p:nvPr/>
        </p:nvSpPr>
        <p:spPr>
          <a:xfrm>
            <a:off x="3398760" y="3678120"/>
            <a:ext cx="73080" cy="7308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"/>
          <p:cNvSpPr/>
          <p:nvPr/>
        </p:nvSpPr>
        <p:spPr>
          <a:xfrm>
            <a:off x="3452760" y="3919680"/>
            <a:ext cx="74520" cy="7272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"/>
          <p:cNvSpPr/>
          <p:nvPr/>
        </p:nvSpPr>
        <p:spPr>
          <a:xfrm>
            <a:off x="3398760" y="3378240"/>
            <a:ext cx="73080" cy="7308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"/>
          <p:cNvSpPr/>
          <p:nvPr/>
        </p:nvSpPr>
        <p:spPr>
          <a:xfrm>
            <a:off x="3508200" y="3919680"/>
            <a:ext cx="73080" cy="7272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"/>
          <p:cNvSpPr/>
          <p:nvPr/>
        </p:nvSpPr>
        <p:spPr>
          <a:xfrm>
            <a:off x="3343320" y="3919680"/>
            <a:ext cx="73080" cy="7272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"/>
          <p:cNvSpPr/>
          <p:nvPr/>
        </p:nvSpPr>
        <p:spPr>
          <a:xfrm>
            <a:off x="3489480" y="3668760"/>
            <a:ext cx="0" cy="14112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"/>
          <p:cNvSpPr/>
          <p:nvPr/>
        </p:nvSpPr>
        <p:spPr>
          <a:xfrm>
            <a:off x="3413160" y="3668760"/>
            <a:ext cx="15228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"/>
          <p:cNvSpPr/>
          <p:nvPr/>
        </p:nvSpPr>
        <p:spPr>
          <a:xfrm flipH="1">
            <a:off x="3412800" y="3668760"/>
            <a:ext cx="15228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"/>
          <p:cNvSpPr/>
          <p:nvPr/>
        </p:nvSpPr>
        <p:spPr>
          <a:xfrm>
            <a:off x="3413160" y="3809880"/>
            <a:ext cx="15228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"/>
          <p:cNvSpPr/>
          <p:nvPr/>
        </p:nvSpPr>
        <p:spPr>
          <a:xfrm flipH="1">
            <a:off x="3412800" y="3809880"/>
            <a:ext cx="15228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"/>
          <p:cNvSpPr/>
          <p:nvPr/>
        </p:nvSpPr>
        <p:spPr>
          <a:xfrm>
            <a:off x="3336840" y="37400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"/>
          <p:cNvSpPr/>
          <p:nvPr/>
        </p:nvSpPr>
        <p:spPr>
          <a:xfrm>
            <a:off x="3355920" y="37400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"/>
          <p:cNvSpPr/>
          <p:nvPr/>
        </p:nvSpPr>
        <p:spPr>
          <a:xfrm>
            <a:off x="3375000" y="374004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"/>
          <p:cNvSpPr/>
          <p:nvPr/>
        </p:nvSpPr>
        <p:spPr>
          <a:xfrm>
            <a:off x="3392640" y="3740040"/>
            <a:ext cx="18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"/>
          <p:cNvSpPr/>
          <p:nvPr/>
        </p:nvSpPr>
        <p:spPr>
          <a:xfrm>
            <a:off x="3411360" y="374004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"/>
          <p:cNvSpPr/>
          <p:nvPr/>
        </p:nvSpPr>
        <p:spPr>
          <a:xfrm>
            <a:off x="3429000" y="37400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"/>
          <p:cNvSpPr/>
          <p:nvPr/>
        </p:nvSpPr>
        <p:spPr>
          <a:xfrm>
            <a:off x="3448080" y="374004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"/>
          <p:cNvSpPr/>
          <p:nvPr/>
        </p:nvSpPr>
        <p:spPr>
          <a:xfrm>
            <a:off x="3465360" y="37400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"/>
          <p:cNvSpPr/>
          <p:nvPr/>
        </p:nvSpPr>
        <p:spPr>
          <a:xfrm>
            <a:off x="3484440" y="374004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"/>
          <p:cNvSpPr/>
          <p:nvPr/>
        </p:nvSpPr>
        <p:spPr>
          <a:xfrm>
            <a:off x="3502080" y="37400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"/>
          <p:cNvSpPr/>
          <p:nvPr/>
        </p:nvSpPr>
        <p:spPr>
          <a:xfrm>
            <a:off x="3521160" y="374004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"/>
          <p:cNvSpPr/>
          <p:nvPr/>
        </p:nvSpPr>
        <p:spPr>
          <a:xfrm>
            <a:off x="3538440" y="37400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"/>
          <p:cNvSpPr/>
          <p:nvPr/>
        </p:nvSpPr>
        <p:spPr>
          <a:xfrm>
            <a:off x="3557520" y="374004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"/>
          <p:cNvSpPr/>
          <p:nvPr/>
        </p:nvSpPr>
        <p:spPr>
          <a:xfrm>
            <a:off x="3575160" y="37400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"/>
          <p:cNvSpPr/>
          <p:nvPr/>
        </p:nvSpPr>
        <p:spPr>
          <a:xfrm>
            <a:off x="3594240" y="374004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"/>
          <p:cNvSpPr/>
          <p:nvPr/>
        </p:nvSpPr>
        <p:spPr>
          <a:xfrm>
            <a:off x="3611520" y="37400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"/>
          <p:cNvSpPr/>
          <p:nvPr/>
        </p:nvSpPr>
        <p:spPr>
          <a:xfrm>
            <a:off x="3630600" y="3740040"/>
            <a:ext cx="126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"/>
          <p:cNvSpPr/>
          <p:nvPr/>
        </p:nvSpPr>
        <p:spPr>
          <a:xfrm>
            <a:off x="4422600" y="3919680"/>
            <a:ext cx="73080" cy="7272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"/>
          <p:cNvSpPr/>
          <p:nvPr/>
        </p:nvSpPr>
        <p:spPr>
          <a:xfrm>
            <a:off x="4478400" y="3919680"/>
            <a:ext cx="73080" cy="7272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"/>
          <p:cNvSpPr/>
          <p:nvPr/>
        </p:nvSpPr>
        <p:spPr>
          <a:xfrm>
            <a:off x="4257720" y="3919680"/>
            <a:ext cx="74520" cy="7272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"/>
          <p:cNvSpPr/>
          <p:nvPr/>
        </p:nvSpPr>
        <p:spPr>
          <a:xfrm>
            <a:off x="4422600" y="3635280"/>
            <a:ext cx="73080" cy="7308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"/>
          <p:cNvSpPr/>
          <p:nvPr/>
        </p:nvSpPr>
        <p:spPr>
          <a:xfrm>
            <a:off x="4368960" y="3919680"/>
            <a:ext cx="72720" cy="7272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"/>
          <p:cNvSpPr/>
          <p:nvPr/>
        </p:nvSpPr>
        <p:spPr>
          <a:xfrm>
            <a:off x="4313160" y="3919680"/>
            <a:ext cx="73080" cy="7272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"/>
          <p:cNvSpPr/>
          <p:nvPr/>
        </p:nvSpPr>
        <p:spPr>
          <a:xfrm>
            <a:off x="4395960" y="3919680"/>
            <a:ext cx="72720" cy="7272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"/>
          <p:cNvSpPr/>
          <p:nvPr/>
        </p:nvSpPr>
        <p:spPr>
          <a:xfrm>
            <a:off x="4340160" y="3919680"/>
            <a:ext cx="73080" cy="7272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"/>
          <p:cNvSpPr/>
          <p:nvPr/>
        </p:nvSpPr>
        <p:spPr>
          <a:xfrm>
            <a:off x="4313160" y="3586320"/>
            <a:ext cx="73080" cy="7272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"/>
          <p:cNvSpPr/>
          <p:nvPr/>
        </p:nvSpPr>
        <p:spPr>
          <a:xfrm>
            <a:off x="4405320" y="3841920"/>
            <a:ext cx="0" cy="9180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"/>
          <p:cNvSpPr/>
          <p:nvPr/>
        </p:nvSpPr>
        <p:spPr>
          <a:xfrm>
            <a:off x="4329000" y="3841920"/>
            <a:ext cx="15264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"/>
          <p:cNvSpPr/>
          <p:nvPr/>
        </p:nvSpPr>
        <p:spPr>
          <a:xfrm flipH="1">
            <a:off x="4329000" y="3841920"/>
            <a:ext cx="15264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"/>
          <p:cNvSpPr/>
          <p:nvPr/>
        </p:nvSpPr>
        <p:spPr>
          <a:xfrm>
            <a:off x="4329000" y="3933720"/>
            <a:ext cx="15264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"/>
          <p:cNvSpPr/>
          <p:nvPr/>
        </p:nvSpPr>
        <p:spPr>
          <a:xfrm flipH="1">
            <a:off x="4329000" y="3933720"/>
            <a:ext cx="15264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"/>
          <p:cNvSpPr/>
          <p:nvPr/>
        </p:nvSpPr>
        <p:spPr>
          <a:xfrm>
            <a:off x="4253040" y="388764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"/>
          <p:cNvSpPr/>
          <p:nvPr/>
        </p:nvSpPr>
        <p:spPr>
          <a:xfrm>
            <a:off x="4270320" y="38876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"/>
          <p:cNvSpPr/>
          <p:nvPr/>
        </p:nvSpPr>
        <p:spPr>
          <a:xfrm>
            <a:off x="4289400" y="388764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"/>
          <p:cNvSpPr/>
          <p:nvPr/>
        </p:nvSpPr>
        <p:spPr>
          <a:xfrm>
            <a:off x="4307040" y="3887640"/>
            <a:ext cx="18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"/>
          <p:cNvSpPr/>
          <p:nvPr/>
        </p:nvSpPr>
        <p:spPr>
          <a:xfrm>
            <a:off x="4325760" y="388764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"/>
          <p:cNvSpPr/>
          <p:nvPr/>
        </p:nvSpPr>
        <p:spPr>
          <a:xfrm>
            <a:off x="4343400" y="38876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"/>
          <p:cNvSpPr/>
          <p:nvPr/>
        </p:nvSpPr>
        <p:spPr>
          <a:xfrm>
            <a:off x="4362480" y="388764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"/>
          <p:cNvSpPr/>
          <p:nvPr/>
        </p:nvSpPr>
        <p:spPr>
          <a:xfrm>
            <a:off x="4379760" y="38876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"/>
          <p:cNvSpPr/>
          <p:nvPr/>
        </p:nvSpPr>
        <p:spPr>
          <a:xfrm>
            <a:off x="4398840" y="388764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"/>
          <p:cNvSpPr/>
          <p:nvPr/>
        </p:nvSpPr>
        <p:spPr>
          <a:xfrm>
            <a:off x="4416480" y="38876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"/>
          <p:cNvSpPr/>
          <p:nvPr/>
        </p:nvSpPr>
        <p:spPr>
          <a:xfrm>
            <a:off x="4435560" y="388764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"/>
          <p:cNvSpPr/>
          <p:nvPr/>
        </p:nvSpPr>
        <p:spPr>
          <a:xfrm>
            <a:off x="4452840" y="38876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"/>
          <p:cNvSpPr/>
          <p:nvPr/>
        </p:nvSpPr>
        <p:spPr>
          <a:xfrm>
            <a:off x="4471920" y="388764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"/>
          <p:cNvSpPr/>
          <p:nvPr/>
        </p:nvSpPr>
        <p:spPr>
          <a:xfrm>
            <a:off x="4489560" y="38876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"/>
          <p:cNvSpPr/>
          <p:nvPr/>
        </p:nvSpPr>
        <p:spPr>
          <a:xfrm>
            <a:off x="4508640" y="388764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"/>
          <p:cNvSpPr/>
          <p:nvPr/>
        </p:nvSpPr>
        <p:spPr>
          <a:xfrm>
            <a:off x="4525920" y="388764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"/>
          <p:cNvSpPr/>
          <p:nvPr/>
        </p:nvSpPr>
        <p:spPr>
          <a:xfrm>
            <a:off x="4545000" y="3887640"/>
            <a:ext cx="126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"/>
          <p:cNvSpPr/>
          <p:nvPr/>
        </p:nvSpPr>
        <p:spPr>
          <a:xfrm>
            <a:off x="5268960" y="3753000"/>
            <a:ext cx="73080" cy="7272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"/>
          <p:cNvSpPr/>
          <p:nvPr/>
        </p:nvSpPr>
        <p:spPr>
          <a:xfrm>
            <a:off x="5295960" y="3506760"/>
            <a:ext cx="73080" cy="7308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"/>
          <p:cNvSpPr/>
          <p:nvPr/>
        </p:nvSpPr>
        <p:spPr>
          <a:xfrm>
            <a:off x="5349960" y="3795840"/>
            <a:ext cx="73080" cy="7272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"/>
          <p:cNvSpPr/>
          <p:nvPr/>
        </p:nvSpPr>
        <p:spPr>
          <a:xfrm>
            <a:off x="5240160" y="3641760"/>
            <a:ext cx="73080" cy="7308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"/>
          <p:cNvSpPr/>
          <p:nvPr/>
        </p:nvSpPr>
        <p:spPr>
          <a:xfrm>
            <a:off x="5240160" y="3719520"/>
            <a:ext cx="73080" cy="7308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"/>
          <p:cNvSpPr/>
          <p:nvPr/>
        </p:nvSpPr>
        <p:spPr>
          <a:xfrm>
            <a:off x="5405400" y="3836880"/>
            <a:ext cx="73080" cy="7308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"/>
          <p:cNvSpPr/>
          <p:nvPr/>
        </p:nvSpPr>
        <p:spPr>
          <a:xfrm>
            <a:off x="5349960" y="3687840"/>
            <a:ext cx="73080" cy="7308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"/>
          <p:cNvSpPr/>
          <p:nvPr/>
        </p:nvSpPr>
        <p:spPr>
          <a:xfrm>
            <a:off x="5295960" y="3854520"/>
            <a:ext cx="73080" cy="7308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"/>
          <p:cNvSpPr/>
          <p:nvPr/>
        </p:nvSpPr>
        <p:spPr>
          <a:xfrm>
            <a:off x="5322960" y="3759120"/>
            <a:ext cx="73080" cy="7308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"/>
          <p:cNvSpPr/>
          <p:nvPr/>
        </p:nvSpPr>
        <p:spPr>
          <a:xfrm>
            <a:off x="5186520" y="3817800"/>
            <a:ext cx="72720" cy="7308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"/>
          <p:cNvSpPr/>
          <p:nvPr/>
        </p:nvSpPr>
        <p:spPr>
          <a:xfrm>
            <a:off x="5349960" y="3736800"/>
            <a:ext cx="73080" cy="7308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"/>
          <p:cNvSpPr/>
          <p:nvPr/>
        </p:nvSpPr>
        <p:spPr>
          <a:xfrm>
            <a:off x="5240160" y="3774960"/>
            <a:ext cx="73080" cy="73080"/>
          </a:xfrm>
          <a:prstGeom prst="ellipse">
            <a:avLst/>
          </a:prstGeom>
          <a:noFill/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"/>
          <p:cNvSpPr/>
          <p:nvPr/>
        </p:nvSpPr>
        <p:spPr>
          <a:xfrm>
            <a:off x="5332320" y="3747960"/>
            <a:ext cx="0" cy="5724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"/>
          <p:cNvSpPr/>
          <p:nvPr/>
        </p:nvSpPr>
        <p:spPr>
          <a:xfrm>
            <a:off x="5256360" y="3747960"/>
            <a:ext cx="15228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"/>
          <p:cNvSpPr/>
          <p:nvPr/>
        </p:nvSpPr>
        <p:spPr>
          <a:xfrm flipH="1">
            <a:off x="5256000" y="3747960"/>
            <a:ext cx="15228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"/>
          <p:cNvSpPr/>
          <p:nvPr/>
        </p:nvSpPr>
        <p:spPr>
          <a:xfrm>
            <a:off x="5256360" y="3805200"/>
            <a:ext cx="15228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"/>
          <p:cNvSpPr/>
          <p:nvPr/>
        </p:nvSpPr>
        <p:spPr>
          <a:xfrm flipH="1">
            <a:off x="5256000" y="3805200"/>
            <a:ext cx="152280" cy="0"/>
          </a:xfrm>
          <a:prstGeom prst="line">
            <a:avLst/>
          </a:prstGeom>
          <a:ln w="270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"/>
          <p:cNvSpPr/>
          <p:nvPr/>
        </p:nvSpPr>
        <p:spPr>
          <a:xfrm>
            <a:off x="5180040" y="377676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"/>
          <p:cNvSpPr/>
          <p:nvPr/>
        </p:nvSpPr>
        <p:spPr>
          <a:xfrm>
            <a:off x="5197320" y="377676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"/>
          <p:cNvSpPr/>
          <p:nvPr/>
        </p:nvSpPr>
        <p:spPr>
          <a:xfrm>
            <a:off x="5216400" y="377676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"/>
          <p:cNvSpPr/>
          <p:nvPr/>
        </p:nvSpPr>
        <p:spPr>
          <a:xfrm>
            <a:off x="5234040" y="377676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"/>
          <p:cNvSpPr/>
          <p:nvPr/>
        </p:nvSpPr>
        <p:spPr>
          <a:xfrm>
            <a:off x="5253120" y="377676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"/>
          <p:cNvSpPr/>
          <p:nvPr/>
        </p:nvSpPr>
        <p:spPr>
          <a:xfrm>
            <a:off x="5270400" y="377676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"/>
          <p:cNvSpPr/>
          <p:nvPr/>
        </p:nvSpPr>
        <p:spPr>
          <a:xfrm>
            <a:off x="5289480" y="377676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"/>
          <p:cNvSpPr/>
          <p:nvPr/>
        </p:nvSpPr>
        <p:spPr>
          <a:xfrm>
            <a:off x="5307120" y="377676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"/>
          <p:cNvSpPr/>
          <p:nvPr/>
        </p:nvSpPr>
        <p:spPr>
          <a:xfrm>
            <a:off x="5326200" y="377676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"/>
          <p:cNvSpPr/>
          <p:nvPr/>
        </p:nvSpPr>
        <p:spPr>
          <a:xfrm>
            <a:off x="5345280" y="377676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"/>
          <p:cNvSpPr/>
          <p:nvPr/>
        </p:nvSpPr>
        <p:spPr>
          <a:xfrm>
            <a:off x="5362560" y="377676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"/>
          <p:cNvSpPr/>
          <p:nvPr/>
        </p:nvSpPr>
        <p:spPr>
          <a:xfrm>
            <a:off x="5381640" y="377676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"/>
          <p:cNvSpPr/>
          <p:nvPr/>
        </p:nvSpPr>
        <p:spPr>
          <a:xfrm>
            <a:off x="5398920" y="377676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"/>
          <p:cNvSpPr/>
          <p:nvPr/>
        </p:nvSpPr>
        <p:spPr>
          <a:xfrm>
            <a:off x="5418000" y="3776760"/>
            <a:ext cx="1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"/>
          <p:cNvSpPr/>
          <p:nvPr/>
        </p:nvSpPr>
        <p:spPr>
          <a:xfrm>
            <a:off x="5435640" y="3776760"/>
            <a:ext cx="1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"/>
          <p:cNvSpPr/>
          <p:nvPr/>
        </p:nvSpPr>
        <p:spPr>
          <a:xfrm>
            <a:off x="5454720" y="3776760"/>
            <a:ext cx="1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"/>
          <p:cNvSpPr/>
          <p:nvPr/>
        </p:nvSpPr>
        <p:spPr>
          <a:xfrm>
            <a:off x="5472000" y="3776760"/>
            <a:ext cx="129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"/>
          <p:cNvSpPr/>
          <p:nvPr/>
        </p:nvSpPr>
        <p:spPr>
          <a:xfrm rot="16200000">
            <a:off x="2254320" y="2985120"/>
            <a:ext cx="8557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TH (pg/ml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"/>
          <p:cNvSpPr/>
          <p:nvPr/>
        </p:nvSpPr>
        <p:spPr>
          <a:xfrm>
            <a:off x="3313080" y="4141800"/>
            <a:ext cx="28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"/>
          <p:cNvSpPr/>
          <p:nvPr/>
        </p:nvSpPr>
        <p:spPr>
          <a:xfrm>
            <a:off x="3790800" y="4141800"/>
            <a:ext cx="240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TZ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"/>
          <p:cNvSpPr/>
          <p:nvPr/>
        </p:nvSpPr>
        <p:spPr>
          <a:xfrm>
            <a:off x="4248000" y="4141800"/>
            <a:ext cx="28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"/>
          <p:cNvSpPr/>
          <p:nvPr/>
        </p:nvSpPr>
        <p:spPr>
          <a:xfrm>
            <a:off x="4754520" y="4141800"/>
            <a:ext cx="27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TZ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18" name=""/>
          <p:cNvGrpSpPr/>
          <p:nvPr/>
        </p:nvGrpSpPr>
        <p:grpSpPr>
          <a:xfrm>
            <a:off x="5181480" y="4141800"/>
            <a:ext cx="709200" cy="152640"/>
            <a:chOff x="5181480" y="4141800"/>
            <a:chExt cx="709200" cy="152640"/>
          </a:xfrm>
        </p:grpSpPr>
        <p:sp>
          <p:nvSpPr>
            <p:cNvPr id="519" name=""/>
            <p:cNvSpPr/>
            <p:nvPr/>
          </p:nvSpPr>
          <p:spPr>
            <a:xfrm>
              <a:off x="5181480" y="4141800"/>
              <a:ext cx="28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"/>
            <p:cNvSpPr/>
            <p:nvPr/>
          </p:nvSpPr>
          <p:spPr>
            <a:xfrm>
              <a:off x="5650560" y="4141800"/>
              <a:ext cx="240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TZ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21" name=""/>
          <p:cNvSpPr/>
          <p:nvPr/>
        </p:nvSpPr>
        <p:spPr>
          <a:xfrm>
            <a:off x="3041280" y="4297320"/>
            <a:ext cx="292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 weeks     15 weeks      18 week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19T01:36:10Z</dcterms:created>
  <dc:creator>fowlkesjohnl</dc:creator>
  <dc:description/>
  <dc:language>en-US</dc:language>
  <cp:lastModifiedBy>fowlkesjohnl</cp:lastModifiedBy>
  <dcterms:modified xsi:type="dcterms:W3CDTF">2011-03-17T20:58:16Z</dcterms:modified>
  <cp:revision>10</cp:revision>
  <dc:subject/>
  <dc:title>Slide 1</dc:title>
</cp:coreProperties>
</file>